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233" autoAdjust="0"/>
    <p:restoredTop sz="96076" autoAdjust="0"/>
  </p:normalViewPr>
  <p:slideViewPr>
    <p:cSldViewPr snapToGrid="0">
      <p:cViewPr>
        <p:scale>
          <a:sx n="70" d="100"/>
          <a:sy n="70" d="100"/>
        </p:scale>
        <p:origin x="2460" y="-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98CE2E9A-BAF1-E903-DE20-56B2E7562C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929" y="2257425"/>
            <a:ext cx="3597280" cy="433220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505487B-1832-4371-A9CD-AEE5359CC473}"/>
              </a:ext>
            </a:extLst>
          </p:cNvPr>
          <p:cNvSpPr/>
          <p:nvPr/>
        </p:nvSpPr>
        <p:spPr>
          <a:xfrm>
            <a:off x="435855" y="6926145"/>
            <a:ext cx="5986290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7: Figure S7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microbial activity of exudate from 8 month after-ripened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rvil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eds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uring germination and seedling growth against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brassicicola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t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FU/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L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sidual dormancy of the seed lots was 32±8%. To produce exudates after germination (0-5 d) and seedling growth (5-10 d) the same experimental design shown in Figure 6 was performed without the 6 d KNO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eatment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are expressed as the normalized growth ratio between the AUC with and without exudate. Points in the box plots corresponds of the three technical replicates per biological replicates (n). n=2 and n=4, respectively for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udates after germination and seedling growth. The dashed line corresponds to control growth without exudate. The star indicates a significant difference from control (t-test or Mann-Whitney test, p&lt;0.05). 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6344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25</TotalTime>
  <Words>152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16</cp:revision>
  <dcterms:created xsi:type="dcterms:W3CDTF">2023-08-10T14:53:51Z</dcterms:created>
  <dcterms:modified xsi:type="dcterms:W3CDTF">2024-01-17T14:40:49Z</dcterms:modified>
</cp:coreProperties>
</file>